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0" r:id="rId2"/>
    <p:sldId id="273" r:id="rId3"/>
    <p:sldId id="267" r:id="rId4"/>
    <p:sldId id="272" r:id="rId5"/>
    <p:sldId id="275" r:id="rId6"/>
    <p:sldId id="278" r:id="rId7"/>
    <p:sldId id="282" r:id="rId8"/>
    <p:sldId id="277" r:id="rId9"/>
  </p:sldIdLst>
  <p:sldSz cx="6858000" cy="9144000" type="letter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106" autoAdjust="0"/>
    <p:restoredTop sz="94660"/>
  </p:normalViewPr>
  <p:slideViewPr>
    <p:cSldViewPr snapToGrid="0">
      <p:cViewPr varScale="1">
        <p:scale>
          <a:sx n="99" d="100"/>
          <a:sy n="99" d="100"/>
        </p:scale>
        <p:origin x="320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fr-FR"/>
              <a:t>Modifier le style des sous-titres du masqu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174962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112617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8695728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029612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05142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9087090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045561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348961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2961444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276922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r>
              <a:rPr lang="fr-FR"/>
              <a:t>Cliquez sur l'icône pour ajouter une image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517619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D4CB9A-386A-404B-B176-312302C6E49A}" type="datetimeFigureOut">
              <a:rPr lang="de-CH" smtClean="0"/>
              <a:t>27.02.2020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FB6E70-72CE-4B03-A802-FE209B096C72}" type="slidenum">
              <a:rPr lang="de-CH" smtClean="0"/>
              <a:t>‹N°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433886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ion of fruit texture with training population optimization for efficient genomic selection in apple</a:t>
            </a:r>
            <a:b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de-CH" sz="3000" dirty="0" err="1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CH" sz="3000" dirty="0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3000" dirty="0" err="1">
                <a:solidFill>
                  <a:srgbClr val="C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b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sz="3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/>
        <p:txBody>
          <a:bodyPr>
            <a:normAutofit fontScale="85000" lnSpcReduction="20000"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it-CH" dirty="0"/>
              <a:t>Morgane Roth</a:t>
            </a:r>
            <a:r>
              <a:rPr lang="it-CH" baseline="30000" dirty="0"/>
              <a:t>1</a:t>
            </a:r>
            <a:r>
              <a:rPr lang="it-CH" dirty="0"/>
              <a:t>, Mario Di Guardo</a:t>
            </a:r>
            <a:r>
              <a:rPr lang="it-CH" baseline="30000" dirty="0"/>
              <a:t>2,3</a:t>
            </a:r>
            <a:r>
              <a:rPr lang="it-CH" dirty="0"/>
              <a:t>, Walter Guerra</a:t>
            </a:r>
            <a:r>
              <a:rPr lang="it-CH" baseline="30000" dirty="0"/>
              <a:t>4</a:t>
            </a:r>
            <a:r>
              <a:rPr lang="it-CH" dirty="0"/>
              <a:t>, Hélène Muranty</a:t>
            </a:r>
            <a:r>
              <a:rPr lang="it-CH" baseline="30000" dirty="0"/>
              <a:t>5</a:t>
            </a:r>
            <a:r>
              <a:rPr lang="it-CH" dirty="0"/>
              <a:t>, Andrea Patocchi</a:t>
            </a:r>
            <a:r>
              <a:rPr lang="it-CH" baseline="30000" dirty="0"/>
              <a:t>1</a:t>
            </a:r>
            <a:r>
              <a:rPr lang="it-CH" dirty="0"/>
              <a:t>, Fabrizio Costa</a:t>
            </a:r>
            <a:r>
              <a:rPr lang="it-CH" baseline="30000" dirty="0"/>
              <a:t>2,6</a:t>
            </a:r>
            <a:endParaRPr lang="fr-FR" dirty="0"/>
          </a:p>
          <a:p>
            <a:pPr lvl="0"/>
            <a:r>
              <a:rPr lang="en-US" dirty="0"/>
              <a:t>Plant Breeding Research Division, </a:t>
            </a:r>
            <a:r>
              <a:rPr lang="en-US" dirty="0" err="1"/>
              <a:t>Agroscope</a:t>
            </a:r>
            <a:r>
              <a:rPr lang="en-US" dirty="0"/>
              <a:t>, </a:t>
            </a:r>
            <a:r>
              <a:rPr lang="en-US" dirty="0" err="1"/>
              <a:t>Wädenswil</a:t>
            </a:r>
            <a:r>
              <a:rPr lang="en-US" dirty="0"/>
              <a:t>, Switzerland</a:t>
            </a:r>
            <a:endParaRPr lang="fr-FR" dirty="0"/>
          </a:p>
          <a:p>
            <a:pPr lvl="0"/>
            <a:r>
              <a:rPr lang="en-US" dirty="0"/>
              <a:t>Department of Genomics and Biology of Fruit Crops, Research and Innovation Centre, Fondazione Edmund Mach (FEM), Via E. Mach 1, 38010 San Michele </a:t>
            </a:r>
            <a:r>
              <a:rPr lang="en-US" dirty="0" err="1"/>
              <a:t>all'Adige</a:t>
            </a:r>
            <a:r>
              <a:rPr lang="en-US" dirty="0"/>
              <a:t>, Italy</a:t>
            </a:r>
            <a:endParaRPr lang="fr-FR" dirty="0"/>
          </a:p>
          <a:p>
            <a:pPr lvl="0"/>
            <a:r>
              <a:rPr lang="it-CH" dirty="0"/>
              <a:t>Dipartimento di Agricoltura, Alimentazione e Ambiente, University of Catania, Catania, Italy</a:t>
            </a:r>
            <a:endParaRPr lang="fr-FR" dirty="0"/>
          </a:p>
          <a:p>
            <a:pPr lvl="0"/>
            <a:r>
              <a:rPr lang="en-US" dirty="0"/>
              <a:t>Research Centre </a:t>
            </a:r>
            <a:r>
              <a:rPr lang="en-US" dirty="0" err="1"/>
              <a:t>Laimburg</a:t>
            </a:r>
            <a:r>
              <a:rPr lang="en-US" dirty="0"/>
              <a:t>, </a:t>
            </a:r>
            <a:r>
              <a:rPr lang="en-US" dirty="0" err="1"/>
              <a:t>Laimburg</a:t>
            </a:r>
            <a:r>
              <a:rPr lang="en-US" dirty="0"/>
              <a:t> 6, 39040 Auer, Italy</a:t>
            </a:r>
            <a:endParaRPr lang="fr-FR" dirty="0"/>
          </a:p>
          <a:p>
            <a:pPr lvl="0"/>
            <a:r>
              <a:rPr lang="en-US" dirty="0"/>
              <a:t> </a:t>
            </a:r>
            <a:r>
              <a:rPr lang="fr-CH" dirty="0"/>
              <a:t>IRHS, INRAE, </a:t>
            </a:r>
            <a:r>
              <a:rPr lang="fr-CH" dirty="0" err="1"/>
              <a:t>Agrocampus</a:t>
            </a:r>
            <a:r>
              <a:rPr lang="fr-CH" dirty="0"/>
              <a:t>-Ouest, Université d'Angers, SFR 4207 </a:t>
            </a:r>
            <a:r>
              <a:rPr lang="fr-CH" dirty="0" err="1"/>
              <a:t>QuaSaV</a:t>
            </a:r>
            <a:r>
              <a:rPr lang="fr-CH" dirty="0"/>
              <a:t>, </a:t>
            </a:r>
            <a:r>
              <a:rPr lang="fr-CH" dirty="0" err="1"/>
              <a:t>Beaucouzé</a:t>
            </a:r>
            <a:r>
              <a:rPr lang="fr-CH" dirty="0"/>
              <a:t>, France</a:t>
            </a:r>
            <a:endParaRPr lang="fr-FR" dirty="0"/>
          </a:p>
          <a:p>
            <a:pPr lvl="0"/>
            <a:r>
              <a:rPr lang="en-US" dirty="0"/>
              <a:t>Center Agriculture Food Environment, University of Trento, Via Mach 1, 38010 San Michele </a:t>
            </a:r>
            <a:r>
              <a:rPr lang="en-US" dirty="0" err="1"/>
              <a:t>all’Adige</a:t>
            </a:r>
            <a:r>
              <a:rPr lang="en-US" dirty="0"/>
              <a:t>, Italy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/>
            </a:r>
            <a:b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296404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/>
          </p:cNvSpPr>
          <p:nvPr/>
        </p:nvSpPr>
        <p:spPr>
          <a:xfrm>
            <a:off x="925178" y="6878887"/>
            <a:ext cx="46482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51435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47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yesia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form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iter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IC)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criminan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ncipal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nen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st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le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kel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umbe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le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Low BIC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cat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ghe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ikelihoo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del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2"/>
          <a:srcRect t="10221"/>
          <a:stretch/>
        </p:blipFill>
        <p:spPr>
          <a:xfrm>
            <a:off x="685800" y="2342147"/>
            <a:ext cx="4887578" cy="43955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333315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/>
          </p:cNvSpPr>
          <p:nvPr/>
        </p:nvSpPr>
        <p:spPr>
          <a:xfrm>
            <a:off x="238634" y="5915509"/>
            <a:ext cx="6466631" cy="961542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51435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47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2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istogram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xtu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enotyp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-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st Linear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bia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dictor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UPs). COL,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le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634" y="2128436"/>
            <a:ext cx="6480000" cy="3448036"/>
          </a:xfrm>
          <a:prstGeom prst="rect">
            <a:avLst/>
          </a:prstGeom>
        </p:spPr>
      </p:pic>
      <p:sp>
        <p:nvSpPr>
          <p:cNvPr id="4" name="ZoneTexte 3"/>
          <p:cNvSpPr txBox="1"/>
          <p:nvPr/>
        </p:nvSpPr>
        <p:spPr>
          <a:xfrm>
            <a:off x="2964284" y="5433365"/>
            <a:ext cx="1028700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800" dirty="0">
                <a:latin typeface="Helvetica" panose="020B0604020202020204" pitchFamily="34" charset="0"/>
                <a:cs typeface="Helvetica" panose="020B0604020202020204" pitchFamily="34" charset="0"/>
              </a:rPr>
              <a:t>BLUPs</a:t>
            </a:r>
            <a:endParaRPr 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" name="ZoneTexte 4"/>
          <p:cNvSpPr txBox="1"/>
          <p:nvPr/>
        </p:nvSpPr>
        <p:spPr>
          <a:xfrm rot="16200000">
            <a:off x="-67719" y="3613235"/>
            <a:ext cx="70811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CH" sz="800" dirty="0">
                <a:latin typeface="Helvetica" panose="020B0604020202020204" pitchFamily="34" charset="0"/>
                <a:cs typeface="Helvetica" panose="020B0604020202020204" pitchFamily="34" charset="0"/>
              </a:rPr>
              <a:t>Count</a:t>
            </a:r>
            <a:endParaRPr lang="en-US" sz="800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24294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78000" y="6410826"/>
            <a:ext cx="62323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Boxplot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howing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tribu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xtu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otypic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u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in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ti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est Linear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nbia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dictor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BLUPs)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n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e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signemen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dividual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ive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scriminan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ncipal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nen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5988" y="1250534"/>
            <a:ext cx="6480000" cy="48340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276995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 txBox="1">
            <a:spLocks/>
          </p:cNvSpPr>
          <p:nvPr/>
        </p:nvSpPr>
        <p:spPr>
          <a:xfrm>
            <a:off x="266700" y="5791452"/>
            <a:ext cx="6413500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51435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2475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4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a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ndar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vi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curaci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ross-validation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i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lec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2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extu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ub-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ynthetic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btain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rom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ncipal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onen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PC1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C2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7574" y="1982804"/>
            <a:ext cx="5808239" cy="36025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42943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25600" y="8151935"/>
            <a:ext cx="58143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" pitchFamily="18" charset="0"/>
              </a:rPr>
              <a:t>Figure S5</a:t>
            </a:r>
            <a:r>
              <a:rPr lang="en-US" sz="1200" dirty="0">
                <a:latin typeface="Times" pitchFamily="18" charset="0"/>
              </a:rPr>
              <a:t>. Observed vs. predicted values in predictions for each family on each trait with model A. Each group of six plots depicts predictions for a given trait (given in the title) in all 6 families. Each dot represents one individual.</a:t>
            </a:r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249" y="186940"/>
            <a:ext cx="2969524" cy="1800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3"/>
          <a:srcRect b="255"/>
          <a:stretch/>
        </p:blipFill>
        <p:spPr>
          <a:xfrm>
            <a:off x="143330" y="2136208"/>
            <a:ext cx="2935443" cy="1795404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32761" y="186940"/>
            <a:ext cx="2922376" cy="1800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5"/>
          <a:srcRect l="106" t="171" r="-106" b="426"/>
          <a:stretch/>
        </p:blipFill>
        <p:spPr>
          <a:xfrm>
            <a:off x="3248175" y="2136208"/>
            <a:ext cx="2906962" cy="1789247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6"/>
          <a:srcRect b="448"/>
          <a:stretch/>
        </p:blipFill>
        <p:spPr>
          <a:xfrm>
            <a:off x="167287" y="4085476"/>
            <a:ext cx="2911486" cy="179193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248175" y="4085476"/>
            <a:ext cx="2966385" cy="1800000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67287" y="6034744"/>
            <a:ext cx="2925714" cy="1800000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 rotWithShape="1">
          <a:blip r:embed="rId9"/>
          <a:srcRect t="324"/>
          <a:stretch/>
        </p:blipFill>
        <p:spPr>
          <a:xfrm>
            <a:off x="3232761" y="6040582"/>
            <a:ext cx="2906962" cy="1794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426585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367999" y="6703279"/>
            <a:ext cx="58143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" pitchFamily="18" charset="0"/>
              </a:rPr>
              <a:t>Figure S5 (continued)</a:t>
            </a:r>
            <a:r>
              <a:rPr lang="en-US" sz="1200" dirty="0">
                <a:latin typeface="Times" pitchFamily="18" charset="0"/>
              </a:rPr>
              <a:t>. Observed vs. predicted values in predictions for each family on each trait with model A. Each page depicts predictions for a given trait (given in the title) in all 6 families. Each dot represents one individual.</a:t>
            </a: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2"/>
          <a:srcRect b="176"/>
          <a:stretch/>
        </p:blipFill>
        <p:spPr>
          <a:xfrm>
            <a:off x="367999" y="466072"/>
            <a:ext cx="2864762" cy="1796837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 rotWithShape="1">
          <a:blip r:embed="rId3"/>
          <a:srcRect b="517"/>
          <a:stretch/>
        </p:blipFill>
        <p:spPr>
          <a:xfrm>
            <a:off x="3374306" y="466072"/>
            <a:ext cx="2853010" cy="179068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4"/>
          <a:srcRect t="407"/>
          <a:stretch/>
        </p:blipFill>
        <p:spPr>
          <a:xfrm>
            <a:off x="367999" y="2472266"/>
            <a:ext cx="2910759" cy="1792669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74306" y="2464936"/>
            <a:ext cx="2914740" cy="1800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3562" y="4463800"/>
            <a:ext cx="2905196" cy="1800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7"/>
          <a:srcRect b="428"/>
          <a:stretch/>
        </p:blipFill>
        <p:spPr>
          <a:xfrm>
            <a:off x="3376215" y="4463800"/>
            <a:ext cx="2912831" cy="17922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326236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99677" y="7711337"/>
            <a:ext cx="627586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CH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6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latedness-ba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incipal-components-base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timiz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ning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opul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dict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ac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amily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4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ptimization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od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u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rai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, ALD; B, FNP, C, PC1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d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, PC2. The legend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pplie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ts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CH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CH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887" y="1949162"/>
            <a:ext cx="3077419" cy="21600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243306" y="1949162"/>
            <a:ext cx="3049240" cy="21600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3943" y="4472942"/>
            <a:ext cx="3060978" cy="2160000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 rotWithShape="1">
          <a:blip r:embed="rId5"/>
          <a:srcRect r="15200"/>
          <a:stretch/>
        </p:blipFill>
        <p:spPr>
          <a:xfrm>
            <a:off x="3243306" y="4472942"/>
            <a:ext cx="3065286" cy="2160000"/>
          </a:xfrm>
          <a:prstGeom prst="rect">
            <a:avLst/>
          </a:prstGeom>
        </p:spPr>
      </p:pic>
      <p:sp>
        <p:nvSpPr>
          <p:cNvPr id="9" name="ZoneTexte 8"/>
          <p:cNvSpPr txBox="1"/>
          <p:nvPr/>
        </p:nvSpPr>
        <p:spPr>
          <a:xfrm>
            <a:off x="-9924" y="1629314"/>
            <a:ext cx="240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A</a:t>
            </a:r>
            <a:endParaRPr lang="en-US" dirty="0"/>
          </a:p>
        </p:txBody>
      </p:sp>
      <p:sp>
        <p:nvSpPr>
          <p:cNvPr id="10" name="ZoneTexte 9"/>
          <p:cNvSpPr txBox="1"/>
          <p:nvPr/>
        </p:nvSpPr>
        <p:spPr>
          <a:xfrm>
            <a:off x="3154606" y="1629314"/>
            <a:ext cx="240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B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-9924" y="4172166"/>
            <a:ext cx="240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C</a:t>
            </a:r>
            <a:endParaRPr lang="en-US" dirty="0"/>
          </a:p>
        </p:txBody>
      </p:sp>
      <p:sp>
        <p:nvSpPr>
          <p:cNvPr id="12" name="ZoneTexte 11"/>
          <p:cNvSpPr txBox="1"/>
          <p:nvPr/>
        </p:nvSpPr>
        <p:spPr>
          <a:xfrm>
            <a:off x="3180743" y="4195018"/>
            <a:ext cx="2406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dirty="0"/>
              <a:t>D</a:t>
            </a:r>
            <a:endParaRPr lang="en-US" dirty="0"/>
          </a:p>
        </p:txBody>
      </p:sp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5"/>
          <a:srcRect l="83773" t="36662" b="35590"/>
          <a:stretch/>
        </p:blipFill>
        <p:spPr>
          <a:xfrm>
            <a:off x="299677" y="6632942"/>
            <a:ext cx="822191" cy="8401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033927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resentation1" id="{4FEC7CDA-A75C-475E-91BB-28D611124670}" vid="{9929A8DE-BDB2-415D-ADFE-DDECAC969A63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0</TotalTime>
  <Words>461</Words>
  <Application>Microsoft Office PowerPoint</Application>
  <PresentationFormat>Format US (216 x 279 mm)</PresentationFormat>
  <Paragraphs>21</Paragraphs>
  <Slides>8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6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8</vt:i4>
      </vt:variant>
    </vt:vector>
  </HeadingPairs>
  <TitlesOfParts>
    <vt:vector size="15" baseType="lpstr">
      <vt:lpstr>Arial</vt:lpstr>
      <vt:lpstr>Calibri</vt:lpstr>
      <vt:lpstr>Calibri Light</vt:lpstr>
      <vt:lpstr>Helvetica</vt:lpstr>
      <vt:lpstr>Times</vt:lpstr>
      <vt:lpstr>Times New Roman</vt:lpstr>
      <vt:lpstr>Thème Office</vt:lpstr>
      <vt:lpstr>Prediction of fruit texture with training population optimization for efficient genomic selection in apple    Supplementary figures      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Bundesverwaltu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oth Morgane AGROSCOPE</dc:creator>
  <cp:lastModifiedBy>Roth Morgane AGROSCOPE</cp:lastModifiedBy>
  <cp:revision>42</cp:revision>
  <cp:lastPrinted>2019-12-02T13:12:58Z</cp:lastPrinted>
  <dcterms:created xsi:type="dcterms:W3CDTF">2019-11-19T13:03:52Z</dcterms:created>
  <dcterms:modified xsi:type="dcterms:W3CDTF">2020-02-27T14:59:39Z</dcterms:modified>
</cp:coreProperties>
</file>